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D8F-42D6-97F1-C5FDCEC3640D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D8F-42D6-97F1-C5FDCEC3640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AB$122:$AB$125</c:f>
                <c:numCache>
                  <c:formatCode>General</c:formatCode>
                  <c:ptCount val="4"/>
                  <c:pt idx="0">
                    <c:v>0.12127061384911689</c:v>
                  </c:pt>
                  <c:pt idx="1">
                    <c:v>8.7761410480097363E-2</c:v>
                  </c:pt>
                  <c:pt idx="2">
                    <c:v>2.37889752496292E-2</c:v>
                  </c:pt>
                  <c:pt idx="3">
                    <c:v>0.23261149357395411</c:v>
                  </c:pt>
                </c:numCache>
              </c:numRef>
            </c:plus>
            <c:minus>
              <c:numRef>
                <c:f>Sheet1!$AB$122:$AB$125</c:f>
                <c:numCache>
                  <c:formatCode>General</c:formatCode>
                  <c:ptCount val="4"/>
                  <c:pt idx="0">
                    <c:v>0.12127061384911689</c:v>
                  </c:pt>
                  <c:pt idx="1">
                    <c:v>8.7761410480097363E-2</c:v>
                  </c:pt>
                  <c:pt idx="2">
                    <c:v>2.37889752496292E-2</c:v>
                  </c:pt>
                  <c:pt idx="3">
                    <c:v>0.232611493573954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Y$122:$Y$125</c:f>
              <c:numCache>
                <c:formatCode>General</c:formatCode>
                <c:ptCount val="4"/>
                <c:pt idx="0">
                  <c:v>0.6756825622737983</c:v>
                </c:pt>
                <c:pt idx="1">
                  <c:v>0.17895732232237405</c:v>
                </c:pt>
                <c:pt idx="2">
                  <c:v>7.3872926833911556E-2</c:v>
                </c:pt>
                <c:pt idx="3">
                  <c:v>0.57610240098218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D8F-42D6-97F1-C5FDCEC364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43550968"/>
        <c:axId val="643556872"/>
      </c:barChart>
      <c:catAx>
        <c:axId val="64355096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3556872"/>
        <c:crosses val="autoZero"/>
        <c:auto val="1"/>
        <c:lblAlgn val="ctr"/>
        <c:lblOffset val="100"/>
        <c:noMultiLvlLbl val="0"/>
      </c:catAx>
      <c:valAx>
        <c:axId val="643556872"/>
        <c:scaling>
          <c:orientation val="minMax"/>
          <c:max val="0.85000000000000009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355096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F$112:$AF$11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2766558411360049</c:v>
                  </c:pt>
                  <c:pt idx="2">
                    <c:v>0.643721672229707</c:v>
                  </c:pt>
                </c:numCache>
              </c:numRef>
            </c:plus>
            <c:minus>
              <c:numRef>
                <c:f>Sheet1!$AF$112:$AF$11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2766558411360049</c:v>
                  </c:pt>
                  <c:pt idx="2">
                    <c:v>0.6437216722297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B$112:$AB$114</c:f>
              <c:numCache>
                <c:formatCode>General</c:formatCode>
                <c:ptCount val="3"/>
                <c:pt idx="0">
                  <c:v>1</c:v>
                </c:pt>
                <c:pt idx="1">
                  <c:v>1.5785047610869611</c:v>
                </c:pt>
                <c:pt idx="2">
                  <c:v>2.5337081013360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2B-4CF0-9DBD-07523A08B2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20507784"/>
        <c:axId val="620508768"/>
      </c:barChart>
      <c:catAx>
        <c:axId val="62050778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0508768"/>
        <c:crosses val="autoZero"/>
        <c:auto val="1"/>
        <c:lblAlgn val="ctr"/>
        <c:lblOffset val="100"/>
        <c:noMultiLvlLbl val="0"/>
      </c:catAx>
      <c:valAx>
        <c:axId val="620508768"/>
        <c:scaling>
          <c:orientation val="minMax"/>
          <c:max val="3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05077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5579615048119"/>
          <c:y val="7.4548702245552628E-2"/>
          <c:w val="0.8904420384951881"/>
          <c:h val="0.897198891805190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2060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00B050"/>
              </a:solidFill>
            </c:spPr>
            <c:extLst>
              <c:ext xmlns:c16="http://schemas.microsoft.com/office/drawing/2014/chart" uri="{C3380CC4-5D6E-409C-BE32-E72D297353CC}">
                <c16:uniqueId val="{00000000-F4F3-4235-8D81-6A7C51848444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M$4:$M$5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5407953753610237</c:v>
                  </c:pt>
                </c:numCache>
              </c:numRef>
            </c:plus>
            <c:minus>
              <c:numRef>
                <c:f>Sheet1!$M$4:$M$5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5407953753610237</c:v>
                  </c:pt>
                </c:numCache>
              </c:numRef>
            </c:minus>
          </c:errBars>
          <c:val>
            <c:numRef>
              <c:f>Sheet1!$G$4:$G$5</c:f>
              <c:numCache>
                <c:formatCode>General</c:formatCode>
                <c:ptCount val="2"/>
                <c:pt idx="0">
                  <c:v>1</c:v>
                </c:pt>
                <c:pt idx="1">
                  <c:v>0.481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AE-45FD-87E1-0F3025430F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83790920"/>
        <c:axId val="190930992"/>
      </c:barChart>
      <c:catAx>
        <c:axId val="83790920"/>
        <c:scaling>
          <c:orientation val="minMax"/>
        </c:scaling>
        <c:delete val="0"/>
        <c:axPos val="b"/>
        <c:majorTickMark val="out"/>
        <c:minorTickMark val="none"/>
        <c:tickLblPos val="none"/>
        <c:crossAx val="190930992"/>
        <c:crosses val="autoZero"/>
        <c:auto val="1"/>
        <c:lblAlgn val="ctr"/>
        <c:lblOffset val="100"/>
        <c:noMultiLvlLbl val="0"/>
      </c:catAx>
      <c:valAx>
        <c:axId val="190930992"/>
        <c:scaling>
          <c:orientation val="minMax"/>
          <c:max val="1.100000000000000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83790920"/>
        <c:crosses val="autoZero"/>
        <c:crossBetween val="between"/>
        <c:majorUnit val="0.5"/>
      </c:valAx>
      <c:spPr>
        <a:noFill/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854B1-0B67-7D09-0898-A312DAF8AA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DCE87C1-13E6-8A3A-88C7-624624A67C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593172-6F67-970D-B136-D07628FD0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501144-6E8A-1025-F030-D511090C9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59F8E-E1A8-FC18-A0F3-619E7DF06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541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C35CB7-DA49-B082-4130-EDD8B77E75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E2905D-482B-4C49-1F3E-B0380EE347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735B41-67D7-3FA6-D574-87313ECBD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4661DD-58CD-B101-0E03-7627371A8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3C87AB-4CC1-BC70-7067-D2E25AB42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557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FC1D68-B3AA-7579-C4D6-A7DB1AF96D9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030C2D-BF60-1B6C-4829-0609BC3CC2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D696D6-FB99-3E77-BB42-0F971E39C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9D2808-4D90-5A2F-FD1C-1FDA1000D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CF8AD1-7A47-0AA8-CD8E-88D2D3664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244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2724B-482A-4CE5-34A6-0463F4B12B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55F815-CCA9-5028-1C5D-26B2721104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14F1CF-AF33-1400-BDD3-B68D58FC4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13C7FE-992D-210A-9DE1-72107583E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C35A9D-0948-3FF0-7598-FE0560C51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3611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16347-820C-9E56-C55D-9ECB9EC915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105102-91AB-BA95-6529-71439B112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AB4BA5-6358-F184-5FC8-D2FBC1B3A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9C96B3-22A8-58E0-3E22-098FF89FA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B04F42-9BD2-5A58-2A17-363080AE0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6840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A8A26D-D2E9-0B9E-20AC-C9ABBE8DB0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FC767F-416D-1C55-D7D3-B7EA5D74EA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7B0014-9B65-31B3-65E7-8FFBFCFC9B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9E3438-5E18-6578-F1DD-AEAE12748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F01AE0-52FF-42DF-7BC3-041398464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F82697-5AFA-7815-88DA-E6F9DB8E2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153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9B3C78-CBBC-8E05-2E61-1E7942E13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597174-E924-2321-107E-889D174DA5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56CAC7-8415-82EA-1960-178F25E2C1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ECFC9E-99FE-04A6-F717-8AC50C7D17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923673-26B3-9BFD-064A-B5E0FB11E7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3746A0-B7D5-6996-6BEB-D68F9F6BB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B166F2-3997-C68F-9BFC-B5C2564C8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2B15DD-86AA-47EA-2AAB-F9E133CEB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0990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7CDACF-5083-146B-DD27-6D4AF024E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2EF53D-156E-4625-B374-2003F5452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4DFF69-4724-A53C-DCF8-47B0AD870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278A67-5643-616D-818D-6274F7139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211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A5D625-6C17-4266-28E6-AC5FED02D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BEBBEE-2D2B-B651-BD1A-4B6649B77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294ADE6-7242-0E93-398C-CCA2C051D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506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C69E06-E60D-9555-7676-BF018291FA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164D6A-0674-0A38-B8C0-47B199B792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CD565C-C9DE-711F-2CED-37215DC5C3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48CC22-A379-1782-1743-8CB39D31B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6C4AB1-E9B0-5A71-9DC4-33FB6971C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8353C4-E57E-B0E4-6B30-EB07061EA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3375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723B7C-67AA-A930-5F6B-C2DE4DFB36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9D89D5C-737D-8633-D51A-8B32F565AC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FDA9D3-822C-6BD8-A951-C0B34B988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FA4684-4A06-B209-B205-458E9C629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497617-8965-437B-37EA-385192CF6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C77BC0-61A9-AB8A-D61B-D7FB4DEEF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348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40CFEC-FB0D-1086-C0EA-2DAF9C8688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FDB7CF-C005-2B89-AB10-3FB13D7A44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9E1987-C613-EA42-76BE-AA7092DE7D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091E-2AEC-4F41-B0FD-946420895996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062B56-4431-8500-29AC-A577A2275E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4AC67F-B3A6-2CB7-CE93-0684CB3F39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D1F50-7182-43BD-88EB-FE5E45A0482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8586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microsoft.com/office/2007/relationships/hdphoto" Target="../media/hdphoto3.wdp"/><Relationship Id="rId18" Type="http://schemas.openxmlformats.org/officeDocument/2006/relationships/image" Target="../media/image10.png"/><Relationship Id="rId3" Type="http://schemas.openxmlformats.org/officeDocument/2006/relationships/image" Target="../media/image2.png"/><Relationship Id="rId21" Type="http://schemas.microsoft.com/office/2007/relationships/hdphoto" Target="../media/hdphoto6.wdp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17" Type="http://schemas.microsoft.com/office/2007/relationships/hdphoto" Target="../media/hdphoto4.wdp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11" Type="http://schemas.microsoft.com/office/2007/relationships/hdphoto" Target="../media/hdphoto2.wdp"/><Relationship Id="rId5" Type="http://schemas.openxmlformats.org/officeDocument/2006/relationships/image" Target="../media/image4.png"/><Relationship Id="rId15" Type="http://schemas.openxmlformats.org/officeDocument/2006/relationships/chart" Target="../charts/chart3.xml"/><Relationship Id="rId23" Type="http://schemas.microsoft.com/office/2007/relationships/hdphoto" Target="../media/hdphoto7.wdp"/><Relationship Id="rId10" Type="http://schemas.openxmlformats.org/officeDocument/2006/relationships/image" Target="../media/image7.png"/><Relationship Id="rId19" Type="http://schemas.microsoft.com/office/2007/relationships/hdphoto" Target="../media/hdphoto5.wdp"/><Relationship Id="rId4" Type="http://schemas.openxmlformats.org/officeDocument/2006/relationships/image" Target="../media/image3.png"/><Relationship Id="rId9" Type="http://schemas.openxmlformats.org/officeDocument/2006/relationships/image" Target="../media/image6.png"/><Relationship Id="rId14" Type="http://schemas.openxmlformats.org/officeDocument/2006/relationships/chart" Target="../charts/chart2.xml"/><Relationship Id="rId2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19674CA-8A02-411D-9B45-020E40B1F3DD}"/>
              </a:ext>
            </a:extLst>
          </p:cNvPr>
          <p:cNvSpPr txBox="1"/>
          <p:nvPr/>
        </p:nvSpPr>
        <p:spPr>
          <a:xfrm>
            <a:off x="1396011" y="21617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ADB8AF30-4E63-46DB-B812-0A4A85B032DB}"/>
              </a:ext>
            </a:extLst>
          </p:cNvPr>
          <p:cNvSpPr txBox="1"/>
          <p:nvPr/>
        </p:nvSpPr>
        <p:spPr>
          <a:xfrm>
            <a:off x="6319544" y="42334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</a:p>
        </p:txBody>
      </p:sp>
      <p:grpSp>
        <p:nvGrpSpPr>
          <p:cNvPr id="229" name="Group 228">
            <a:extLst>
              <a:ext uri="{FF2B5EF4-FFF2-40B4-BE49-F238E27FC236}">
                <a16:creationId xmlns:a16="http://schemas.microsoft.com/office/drawing/2014/main" id="{C4A59BC6-7778-485F-9C59-BE1CD0FFEAC0}"/>
              </a:ext>
            </a:extLst>
          </p:cNvPr>
          <p:cNvGrpSpPr/>
          <p:nvPr/>
        </p:nvGrpSpPr>
        <p:grpSpPr>
          <a:xfrm>
            <a:off x="6573760" y="685671"/>
            <a:ext cx="4505226" cy="2226166"/>
            <a:chOff x="5744419" y="1608461"/>
            <a:chExt cx="4505226" cy="2226166"/>
          </a:xfrm>
        </p:grpSpPr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2BBB2D68-26D9-429D-B3F8-682E816F068B}"/>
                </a:ext>
              </a:extLst>
            </p:cNvPr>
            <p:cNvSpPr txBox="1"/>
            <p:nvPr/>
          </p:nvSpPr>
          <p:spPr>
            <a:xfrm>
              <a:off x="7359232" y="1743321"/>
              <a:ext cx="28904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            IP:</a:t>
              </a:r>
            </a:p>
            <a:p>
              <a:r>
                <a:rPr lang="en-GB" sz="1200" dirty="0"/>
                <a:t>            RanBP1(RBD)-GST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9635E3D-94BC-4A35-9C4D-D453DFCCBC9C}"/>
                </a:ext>
              </a:extLst>
            </p:cNvPr>
            <p:cNvSpPr txBox="1"/>
            <p:nvPr/>
          </p:nvSpPr>
          <p:spPr>
            <a:xfrm>
              <a:off x="6079952" y="2692324"/>
              <a:ext cx="3706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HA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71E848CA-4952-481E-B441-09FAC585C107}"/>
                </a:ext>
              </a:extLst>
            </p:cNvPr>
            <p:cNvSpPr txBox="1"/>
            <p:nvPr/>
          </p:nvSpPr>
          <p:spPr>
            <a:xfrm>
              <a:off x="5811857" y="3101311"/>
              <a:ext cx="70617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200" dirty="0"/>
                <a:t>GAPDH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3B38A44-5361-4C7E-AC56-F2C367A41A7C}"/>
                </a:ext>
              </a:extLst>
            </p:cNvPr>
            <p:cNvSpPr txBox="1"/>
            <p:nvPr/>
          </p:nvSpPr>
          <p:spPr>
            <a:xfrm>
              <a:off x="7093916" y="1608461"/>
              <a:ext cx="7411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RCC1-HA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90D983EC-5F38-45DA-86DF-23A71D090764}"/>
                </a:ext>
              </a:extLst>
            </p:cNvPr>
            <p:cNvSpPr txBox="1"/>
            <p:nvPr/>
          </p:nvSpPr>
          <p:spPr>
            <a:xfrm>
              <a:off x="6469261" y="1608461"/>
              <a:ext cx="3947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/>
                <a:t>vec</a:t>
              </a:r>
              <a:endParaRPr lang="en-GB" sz="1200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39C0BF9-41C1-4391-BD52-73938AA34A1C}"/>
                </a:ext>
              </a:extLst>
            </p:cNvPr>
            <p:cNvSpPr txBox="1"/>
            <p:nvPr/>
          </p:nvSpPr>
          <p:spPr>
            <a:xfrm>
              <a:off x="5744419" y="1715468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IB: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C70323E5-F21C-42EB-B96A-AFCB3DC49258}"/>
                </a:ext>
              </a:extLst>
            </p:cNvPr>
            <p:cNvGrpSpPr/>
            <p:nvPr/>
          </p:nvGrpSpPr>
          <p:grpSpPr>
            <a:xfrm>
              <a:off x="5964078" y="1846319"/>
              <a:ext cx="502061" cy="392744"/>
              <a:chOff x="7468432" y="1049827"/>
              <a:chExt cx="502061" cy="392744"/>
            </a:xfrm>
          </p:grpSpPr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3375EECB-969A-409E-B423-5CB881764FDA}"/>
                  </a:ext>
                </a:extLst>
              </p:cNvPr>
              <p:cNvSpPr txBox="1"/>
              <p:nvPr/>
            </p:nvSpPr>
            <p:spPr>
              <a:xfrm>
                <a:off x="7512810" y="1049827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Ran</a:t>
                </a:r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066605EE-8A54-4B4C-A336-9FC8D81B06BC}"/>
                  </a:ext>
                </a:extLst>
              </p:cNvPr>
              <p:cNvSpPr/>
              <p:nvPr/>
            </p:nvSpPr>
            <p:spPr>
              <a:xfrm>
                <a:off x="7468432" y="1180961"/>
                <a:ext cx="502061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100" dirty="0"/>
                  <a:t>(GTP)</a:t>
                </a:r>
              </a:p>
            </p:txBody>
          </p:sp>
        </p:grp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5AD5D32F-856B-4E5B-8E6F-AA7736CF140C}"/>
                </a:ext>
              </a:extLst>
            </p:cNvPr>
            <p:cNvGrpSpPr/>
            <p:nvPr/>
          </p:nvGrpSpPr>
          <p:grpSpPr>
            <a:xfrm>
              <a:off x="5900318" y="2229060"/>
              <a:ext cx="557425" cy="379690"/>
              <a:chOff x="7416348" y="1437402"/>
              <a:chExt cx="557425" cy="379690"/>
            </a:xfrm>
          </p:grpSpPr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79191992-665D-4951-AA25-ABB50747332E}"/>
                  </a:ext>
                </a:extLst>
              </p:cNvPr>
              <p:cNvSpPr txBox="1"/>
              <p:nvPr/>
            </p:nvSpPr>
            <p:spPr>
              <a:xfrm>
                <a:off x="7416348" y="1437402"/>
                <a:ext cx="5277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   Ran</a:t>
                </a:r>
              </a:p>
            </p:txBody>
          </p:sp>
          <p:sp>
            <p:nvSpPr>
              <p:cNvPr id="88" name="Rectangle 87">
                <a:extLst>
                  <a:ext uri="{FF2B5EF4-FFF2-40B4-BE49-F238E27FC236}">
                    <a16:creationId xmlns:a16="http://schemas.microsoft.com/office/drawing/2014/main" id="{7596CF03-71CA-47BE-8599-04F44D317024}"/>
                  </a:ext>
                </a:extLst>
              </p:cNvPr>
              <p:cNvSpPr/>
              <p:nvPr/>
            </p:nvSpPr>
            <p:spPr>
              <a:xfrm>
                <a:off x="7436446" y="1555482"/>
                <a:ext cx="537327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100" dirty="0"/>
                  <a:t>(total)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0A0C9A85-E7E2-432E-AD1B-1DFBD4667CFB}"/>
                </a:ext>
              </a:extLst>
            </p:cNvPr>
            <p:cNvGrpSpPr/>
            <p:nvPr/>
          </p:nvGrpSpPr>
          <p:grpSpPr>
            <a:xfrm>
              <a:off x="6387365" y="2711353"/>
              <a:ext cx="1365868" cy="310085"/>
              <a:chOff x="6345999" y="1832153"/>
              <a:chExt cx="1365868" cy="310085"/>
            </a:xfrm>
          </p:grpSpPr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7E893BA6-2972-4C9B-8B33-C96E1356B5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349596" y="1842110"/>
                <a:ext cx="1357489" cy="300128"/>
              </a:xfrm>
              <a:prstGeom prst="rect">
                <a:avLst/>
              </a:prstGeom>
            </p:spPr>
          </p:pic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219AB09C-1FAC-428A-A2F4-3BD84F6F27D6}"/>
                  </a:ext>
                </a:extLst>
              </p:cNvPr>
              <p:cNvSpPr/>
              <p:nvPr/>
            </p:nvSpPr>
            <p:spPr>
              <a:xfrm>
                <a:off x="6345999" y="1832153"/>
                <a:ext cx="1365868" cy="30566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BD64C35A-41FB-495E-BCAE-9067A7A435F4}"/>
                </a:ext>
              </a:extLst>
            </p:cNvPr>
            <p:cNvGrpSpPr/>
            <p:nvPr/>
          </p:nvGrpSpPr>
          <p:grpSpPr>
            <a:xfrm>
              <a:off x="7833887" y="2428589"/>
              <a:ext cx="276999" cy="824983"/>
              <a:chOff x="7792521" y="1428813"/>
              <a:chExt cx="276999" cy="824983"/>
            </a:xfrm>
          </p:grpSpPr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1DE55E5C-E844-40A0-ACB0-1FF22E252713}"/>
                  </a:ext>
                </a:extLst>
              </p:cNvPr>
              <p:cNvSpPr txBox="1"/>
              <p:nvPr/>
            </p:nvSpPr>
            <p:spPr>
              <a:xfrm rot="5400000">
                <a:off x="7675181" y="1739135"/>
                <a:ext cx="511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input</a:t>
                </a:r>
              </a:p>
            </p:txBody>
          </p:sp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A7F93C9F-3176-4876-85E2-8AA23D742D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2521" y="1428813"/>
                <a:ext cx="0" cy="82498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628A2E8C-5005-435B-ADF7-C674DB778E0B}"/>
                </a:ext>
              </a:extLst>
            </p:cNvPr>
            <p:cNvGrpSpPr/>
            <p:nvPr/>
          </p:nvGrpSpPr>
          <p:grpSpPr>
            <a:xfrm>
              <a:off x="6390437" y="2281700"/>
              <a:ext cx="1378111" cy="387572"/>
              <a:chOff x="6349071" y="1352260"/>
              <a:chExt cx="1378111" cy="387572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A175B535-C2FE-4961-9680-00844A1498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49598" y="1369424"/>
                <a:ext cx="1377584" cy="370408"/>
              </a:xfrm>
              <a:prstGeom prst="rect">
                <a:avLst/>
              </a:prstGeom>
            </p:spPr>
          </p:pic>
          <p:sp>
            <p:nvSpPr>
              <p:cNvPr id="111" name="Rectangle 110">
                <a:extLst>
                  <a:ext uri="{FF2B5EF4-FFF2-40B4-BE49-F238E27FC236}">
                    <a16:creationId xmlns:a16="http://schemas.microsoft.com/office/drawing/2014/main" id="{FB34891C-ECB5-4F9F-8453-61E061D29C14}"/>
                  </a:ext>
                </a:extLst>
              </p:cNvPr>
              <p:cNvSpPr/>
              <p:nvPr/>
            </p:nvSpPr>
            <p:spPr>
              <a:xfrm>
                <a:off x="6349071" y="1352260"/>
                <a:ext cx="1365868" cy="38339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04D615E0-EC41-405A-86CE-F67FFF35CE96}"/>
                </a:ext>
              </a:extLst>
            </p:cNvPr>
            <p:cNvGrpSpPr/>
            <p:nvPr/>
          </p:nvGrpSpPr>
          <p:grpSpPr>
            <a:xfrm>
              <a:off x="6394224" y="3053612"/>
              <a:ext cx="1365868" cy="415834"/>
              <a:chOff x="6332762" y="2254796"/>
              <a:chExt cx="1365868" cy="415834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3F00D158-5E14-416B-8C30-B6F59684E7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352290" y="2254796"/>
                <a:ext cx="1346340" cy="415834"/>
              </a:xfrm>
              <a:prstGeom prst="rect">
                <a:avLst/>
              </a:prstGeom>
            </p:spPr>
          </p:pic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id="{0BD1C09B-03CE-4370-976A-B57D8BA43352}"/>
                  </a:ext>
                </a:extLst>
              </p:cNvPr>
              <p:cNvSpPr/>
              <p:nvPr/>
            </p:nvSpPr>
            <p:spPr>
              <a:xfrm>
                <a:off x="6332762" y="2254797"/>
                <a:ext cx="1365868" cy="3246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7984010-10A1-42FE-87ED-6D20022FF804}"/>
                </a:ext>
              </a:extLst>
            </p:cNvPr>
            <p:cNvGrpSpPr/>
            <p:nvPr/>
          </p:nvGrpSpPr>
          <p:grpSpPr>
            <a:xfrm>
              <a:off x="6396704" y="1865748"/>
              <a:ext cx="1437183" cy="390893"/>
              <a:chOff x="6355338" y="865972"/>
              <a:chExt cx="1437183" cy="390893"/>
            </a:xfrm>
          </p:grpSpPr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4CCCE488-E04F-481D-8F58-809C48D94B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355338" y="898987"/>
                <a:ext cx="1376242" cy="357878"/>
              </a:xfrm>
              <a:prstGeom prst="rect">
                <a:avLst/>
              </a:prstGeom>
            </p:spPr>
          </p:pic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94FB913F-BD91-40CF-ACFD-54CDE65965E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76665" y="866315"/>
                <a:ext cx="32021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>
                <a:extLst>
                  <a:ext uri="{FF2B5EF4-FFF2-40B4-BE49-F238E27FC236}">
                    <a16:creationId xmlns:a16="http://schemas.microsoft.com/office/drawing/2014/main" id="{EF114360-7C5A-4CE4-A418-1EF8853B39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93282" y="865972"/>
                <a:ext cx="32021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>
                <a:extLst>
                  <a:ext uri="{FF2B5EF4-FFF2-40B4-BE49-F238E27FC236}">
                    <a16:creationId xmlns:a16="http://schemas.microsoft.com/office/drawing/2014/main" id="{F99B535B-7EBE-4795-A6A6-A11A8FAB75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2521" y="969371"/>
                <a:ext cx="0" cy="15362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4674FB90-240C-46DC-AF9C-93CE57CFBB23}"/>
                  </a:ext>
                </a:extLst>
              </p:cNvPr>
              <p:cNvSpPr/>
              <p:nvPr/>
            </p:nvSpPr>
            <p:spPr>
              <a:xfrm>
                <a:off x="6360525" y="893622"/>
                <a:ext cx="1365868" cy="35657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</p:grp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4B567A6A-DCBA-4CCF-953C-52B70C16FADC}"/>
                </a:ext>
              </a:extLst>
            </p:cNvPr>
            <p:cNvSpPr txBox="1"/>
            <p:nvPr/>
          </p:nvSpPr>
          <p:spPr>
            <a:xfrm>
              <a:off x="6417323" y="3395562"/>
              <a:ext cx="12939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      S4D   C    S4D</a:t>
              </a:r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A1D9616E-ECD4-4B2B-8797-FB85DD79A32D}"/>
                </a:ext>
              </a:extLst>
            </p:cNvPr>
            <p:cNvGrpSpPr/>
            <p:nvPr/>
          </p:nvGrpSpPr>
          <p:grpSpPr>
            <a:xfrm>
              <a:off x="8063012" y="2157812"/>
              <a:ext cx="2082029" cy="1676815"/>
              <a:chOff x="7974021" y="1158036"/>
              <a:chExt cx="2082029" cy="1676815"/>
            </a:xfrm>
          </p:grpSpPr>
          <p:grpSp>
            <p:nvGrpSpPr>
              <p:cNvPr id="114" name="Group 113">
                <a:extLst>
                  <a:ext uri="{FF2B5EF4-FFF2-40B4-BE49-F238E27FC236}">
                    <a16:creationId xmlns:a16="http://schemas.microsoft.com/office/drawing/2014/main" id="{6EC970C0-39D8-4E66-9DE8-DE504AA01C8A}"/>
                  </a:ext>
                </a:extLst>
              </p:cNvPr>
              <p:cNvGrpSpPr/>
              <p:nvPr/>
            </p:nvGrpSpPr>
            <p:grpSpPr>
              <a:xfrm>
                <a:off x="8063719" y="1158036"/>
                <a:ext cx="1992331" cy="1676815"/>
                <a:chOff x="6286800" y="2136656"/>
                <a:chExt cx="1627506" cy="1676815"/>
              </a:xfrm>
            </p:grpSpPr>
            <p:graphicFrame>
              <p:nvGraphicFramePr>
                <p:cNvPr id="49" name="Chart 48">
                  <a:extLst>
                    <a:ext uri="{FF2B5EF4-FFF2-40B4-BE49-F238E27FC236}">
                      <a16:creationId xmlns:a16="http://schemas.microsoft.com/office/drawing/2014/main" id="{546A234C-ED44-4BE4-9207-2A43299DDF27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6286800" y="2136656"/>
                <a:ext cx="1605792" cy="133894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726F5FD0-427F-42E4-BF24-19434D5B92A0}"/>
                    </a:ext>
                  </a:extLst>
                </p:cNvPr>
                <p:cNvSpPr txBox="1"/>
                <p:nvPr/>
              </p:nvSpPr>
              <p:spPr>
                <a:xfrm>
                  <a:off x="6643798" y="3304611"/>
                  <a:ext cx="117223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C      S4D     C      S4D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C46CF66A-D6C0-420C-A011-09315789F298}"/>
                    </a:ext>
                  </a:extLst>
                </p:cNvPr>
                <p:cNvSpPr txBox="1"/>
                <p:nvPr/>
              </p:nvSpPr>
              <p:spPr>
                <a:xfrm>
                  <a:off x="7173141" y="3494980"/>
                  <a:ext cx="741165" cy="3184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RCC1-HA</a:t>
                  </a:r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56F1AA16-0CBD-4FD5-9166-2E196D9BB6B3}"/>
                    </a:ext>
                  </a:extLst>
                </p:cNvPr>
                <p:cNvSpPr txBox="1"/>
                <p:nvPr/>
              </p:nvSpPr>
              <p:spPr>
                <a:xfrm>
                  <a:off x="6720641" y="3484767"/>
                  <a:ext cx="394788" cy="3184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 err="1"/>
                    <a:t>vec</a:t>
                  </a:r>
                  <a:endParaRPr lang="en-GB" sz="1200" dirty="0"/>
                </a:p>
              </p:txBody>
            </p:sp>
            <p:cxnSp>
              <p:nvCxnSpPr>
                <p:cNvPr id="95" name="Straight Connector 94">
                  <a:extLst>
                    <a:ext uri="{FF2B5EF4-FFF2-40B4-BE49-F238E27FC236}">
                      <a16:creationId xmlns:a16="http://schemas.microsoft.com/office/drawing/2014/main" id="{45037CF1-1BCC-47AC-B343-BA73D09E4E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724747" y="3549998"/>
                  <a:ext cx="32021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Straight Connector 95">
                  <a:extLst>
                    <a:ext uri="{FF2B5EF4-FFF2-40B4-BE49-F238E27FC236}">
                      <a16:creationId xmlns:a16="http://schemas.microsoft.com/office/drawing/2014/main" id="{5FB50AB3-76B3-4CD3-9D73-66AE7584CA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17444" y="3538424"/>
                  <a:ext cx="32021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F84F46FA-10A5-4F8F-95E1-115983DDCA58}"/>
                  </a:ext>
                </a:extLst>
              </p:cNvPr>
              <p:cNvSpPr txBox="1"/>
              <p:nvPr/>
            </p:nvSpPr>
            <p:spPr>
              <a:xfrm rot="16200000">
                <a:off x="7576893" y="1725911"/>
                <a:ext cx="10712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band intensity</a:t>
                </a:r>
              </a:p>
            </p:txBody>
          </p:sp>
        </p:grpSp>
      </p:grpSp>
      <p:sp>
        <p:nvSpPr>
          <p:cNvPr id="191" name="TextBox 190">
            <a:extLst>
              <a:ext uri="{FF2B5EF4-FFF2-40B4-BE49-F238E27FC236}">
                <a16:creationId xmlns:a16="http://schemas.microsoft.com/office/drawing/2014/main" id="{92E582AD-7DC2-4D00-85C8-E7890574B3B3}"/>
              </a:ext>
            </a:extLst>
          </p:cNvPr>
          <p:cNvSpPr txBox="1"/>
          <p:nvPr/>
        </p:nvSpPr>
        <p:spPr>
          <a:xfrm>
            <a:off x="1396011" y="42334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96B4403F-FA96-4C07-94E5-CB203DFFF604}"/>
              </a:ext>
            </a:extLst>
          </p:cNvPr>
          <p:cNvGrpSpPr/>
          <p:nvPr/>
        </p:nvGrpSpPr>
        <p:grpSpPr>
          <a:xfrm>
            <a:off x="1442804" y="2410367"/>
            <a:ext cx="3665225" cy="1913188"/>
            <a:chOff x="613463" y="3333157"/>
            <a:chExt cx="3665225" cy="191318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7A0E97F-6B59-4E5A-A6F2-094D9ABCF6B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4139" y="3492530"/>
              <a:ext cx="1295623" cy="39898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B001EA2-98E8-4653-9077-7F4CC43157B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269485" y="4648133"/>
              <a:ext cx="1293601" cy="39011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11589A0-C2B3-47B1-9089-87C5F642DE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72340" y="3921518"/>
              <a:ext cx="1293601" cy="300742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13E1CF6C-A4A8-451D-BEEC-9D487AC31719}"/>
                </a:ext>
              </a:extLst>
            </p:cNvPr>
            <p:cNvSpPr/>
            <p:nvPr/>
          </p:nvSpPr>
          <p:spPr>
            <a:xfrm>
              <a:off x="1272340" y="3482169"/>
              <a:ext cx="1293601" cy="3979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490BC1B-CCB2-4B2E-BDF1-A483FA4DD8A7}"/>
                </a:ext>
              </a:extLst>
            </p:cNvPr>
            <p:cNvSpPr/>
            <p:nvPr/>
          </p:nvSpPr>
          <p:spPr>
            <a:xfrm>
              <a:off x="1269486" y="4641814"/>
              <a:ext cx="1293601" cy="3905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/>
            </a:p>
          </p:txBody>
        </p:sp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6CFF95C5-293C-470C-B860-CB9708780EA6}"/>
                </a:ext>
              </a:extLst>
            </p:cNvPr>
            <p:cNvGrpSpPr/>
            <p:nvPr/>
          </p:nvGrpSpPr>
          <p:grpSpPr>
            <a:xfrm>
              <a:off x="1272340" y="4248603"/>
              <a:ext cx="1300507" cy="354934"/>
              <a:chOff x="1888570" y="2300008"/>
              <a:chExt cx="1765382" cy="398152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E355CC1F-BFA9-4273-BBC2-E94C1DD3A4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97945" y="2310569"/>
                <a:ext cx="1756007" cy="387591"/>
              </a:xfrm>
              <a:prstGeom prst="rect">
                <a:avLst/>
              </a:prstGeom>
            </p:spPr>
          </p:pic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00D07BE0-4501-47F6-8558-E0FFF53C36A8}"/>
                  </a:ext>
                </a:extLst>
              </p:cNvPr>
              <p:cNvSpPr/>
              <p:nvPr/>
            </p:nvSpPr>
            <p:spPr>
              <a:xfrm>
                <a:off x="1888570" y="2300008"/>
                <a:ext cx="1756007" cy="39103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</p:grp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40B2A8B-6AAA-405E-82FB-7503CACA25D0}"/>
                </a:ext>
              </a:extLst>
            </p:cNvPr>
            <p:cNvSpPr/>
            <p:nvPr/>
          </p:nvSpPr>
          <p:spPr>
            <a:xfrm>
              <a:off x="1272340" y="3915012"/>
              <a:ext cx="1293601" cy="3010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EFD1A48-4656-4423-81CD-9BA75DE82D25}"/>
                </a:ext>
              </a:extLst>
            </p:cNvPr>
            <p:cNvSpPr txBox="1"/>
            <p:nvPr/>
          </p:nvSpPr>
          <p:spPr>
            <a:xfrm>
              <a:off x="689702" y="4697303"/>
              <a:ext cx="643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GAPDH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057E3F6-C43E-4419-BA99-931297B5AFFC}"/>
                </a:ext>
              </a:extLst>
            </p:cNvPr>
            <p:cNvSpPr txBox="1"/>
            <p:nvPr/>
          </p:nvSpPr>
          <p:spPr>
            <a:xfrm>
              <a:off x="613463" y="4287778"/>
              <a:ext cx="719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PlexinB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9B218AF-C55D-4C1D-A689-7B05340D0064}"/>
                </a:ext>
              </a:extLst>
            </p:cNvPr>
            <p:cNvSpPr txBox="1"/>
            <p:nvPr/>
          </p:nvSpPr>
          <p:spPr>
            <a:xfrm>
              <a:off x="1313870" y="4999413"/>
              <a:ext cx="196264" cy="2469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1AB445D-DD14-40B0-AE73-C61A7DE9A56E}"/>
                </a:ext>
              </a:extLst>
            </p:cNvPr>
            <p:cNvSpPr txBox="1"/>
            <p:nvPr/>
          </p:nvSpPr>
          <p:spPr>
            <a:xfrm>
              <a:off x="1756747" y="4999413"/>
              <a:ext cx="264755" cy="2469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si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23669BB-2ACD-4C9A-8F2D-DB40574A7A36}"/>
                </a:ext>
              </a:extLst>
            </p:cNvPr>
            <p:cNvSpPr txBox="1"/>
            <p:nvPr/>
          </p:nvSpPr>
          <p:spPr>
            <a:xfrm>
              <a:off x="2198640" y="4990789"/>
              <a:ext cx="264755" cy="2469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si2</a:t>
              </a:r>
            </a:p>
          </p:txBody>
        </p:sp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5C36F214-A55C-499A-BB6E-ABDCFF22FD99}"/>
                </a:ext>
              </a:extLst>
            </p:cNvPr>
            <p:cNvGrpSpPr/>
            <p:nvPr/>
          </p:nvGrpSpPr>
          <p:grpSpPr>
            <a:xfrm>
              <a:off x="2904790" y="3837926"/>
              <a:ext cx="1373898" cy="1329325"/>
              <a:chOff x="4104549" y="1281112"/>
              <a:chExt cx="1581945" cy="1491188"/>
            </a:xfrm>
          </p:grpSpPr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F6D1E498-0E75-49BB-B1DD-E545E19934C2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4228183" y="1281112"/>
              <a:ext cx="1458311" cy="14911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0A50370-D5A7-44FC-8CAA-AEB8A1E942D5}"/>
                  </a:ext>
                </a:extLst>
              </p:cNvPr>
              <p:cNvSpPr txBox="1"/>
              <p:nvPr/>
            </p:nvSpPr>
            <p:spPr>
              <a:xfrm>
                <a:off x="4889615" y="1734595"/>
                <a:ext cx="27465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*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3CD27E70-8F00-46A1-821E-857BA6222825}"/>
                  </a:ext>
                </a:extLst>
              </p:cNvPr>
              <p:cNvSpPr txBox="1"/>
              <p:nvPr/>
            </p:nvSpPr>
            <p:spPr>
              <a:xfrm>
                <a:off x="5164988" y="1281112"/>
                <a:ext cx="27465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/>
                  <a:t>*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22F0F63D-55CA-456E-887B-44EEE230ED23}"/>
                  </a:ext>
                </a:extLst>
              </p:cNvPr>
              <p:cNvSpPr txBox="1"/>
              <p:nvPr/>
            </p:nvSpPr>
            <p:spPr>
              <a:xfrm rot="16200000">
                <a:off x="3707421" y="1925750"/>
                <a:ext cx="10712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band intensity</a:t>
                </a:r>
              </a:p>
            </p:txBody>
          </p:sp>
        </p:grp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710C72C9-AE87-485B-A8B1-3E31A9745583}"/>
                </a:ext>
              </a:extLst>
            </p:cNvPr>
            <p:cNvSpPr txBox="1"/>
            <p:nvPr/>
          </p:nvSpPr>
          <p:spPr>
            <a:xfrm>
              <a:off x="2124967" y="3463696"/>
              <a:ext cx="2129286" cy="411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            IP:</a:t>
              </a:r>
            </a:p>
            <a:p>
              <a:r>
                <a:rPr lang="en-GB" sz="1200" dirty="0"/>
                <a:t>            RanBP1(RBD)-GST</a:t>
              </a:r>
            </a:p>
          </p:txBody>
        </p:sp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CDBC2F68-C3BB-42AD-84F2-C3C5AD6E21A4}"/>
                </a:ext>
              </a:extLst>
            </p:cNvPr>
            <p:cNvGrpSpPr/>
            <p:nvPr/>
          </p:nvGrpSpPr>
          <p:grpSpPr>
            <a:xfrm>
              <a:off x="2655202" y="4119803"/>
              <a:ext cx="238893" cy="735434"/>
              <a:chOff x="7792521" y="1647888"/>
              <a:chExt cx="324287" cy="824983"/>
            </a:xfrm>
          </p:grpSpPr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1FBBB371-4D0A-42DB-B2E1-C5DA5339B863}"/>
                  </a:ext>
                </a:extLst>
              </p:cNvPr>
              <p:cNvSpPr txBox="1"/>
              <p:nvPr/>
            </p:nvSpPr>
            <p:spPr>
              <a:xfrm rot="5400000">
                <a:off x="7722469" y="1815336"/>
                <a:ext cx="511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input</a:t>
                </a:r>
              </a:p>
            </p:txBody>
          </p:sp>
          <p:cxnSp>
            <p:nvCxnSpPr>
              <p:cNvPr id="124" name="Straight Connector 123">
                <a:extLst>
                  <a:ext uri="{FF2B5EF4-FFF2-40B4-BE49-F238E27FC236}">
                    <a16:creationId xmlns:a16="http://schemas.microsoft.com/office/drawing/2014/main" id="{AF4BB150-6C69-4F62-88BB-3EA434EE40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2521" y="1647888"/>
                <a:ext cx="0" cy="82498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CE9D00A2-FF86-4C4A-89A1-87D14AEF6953}"/>
                </a:ext>
              </a:extLst>
            </p:cNvPr>
            <p:cNvSpPr txBox="1"/>
            <p:nvPr/>
          </p:nvSpPr>
          <p:spPr>
            <a:xfrm>
              <a:off x="3328045" y="4997424"/>
              <a:ext cx="196264" cy="2469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073D552C-A4CD-4B0A-8FE2-CA82DDE3F38A}"/>
                </a:ext>
              </a:extLst>
            </p:cNvPr>
            <p:cNvSpPr txBox="1"/>
            <p:nvPr/>
          </p:nvSpPr>
          <p:spPr>
            <a:xfrm>
              <a:off x="3558813" y="4997424"/>
              <a:ext cx="264755" cy="2469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si1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DE4A9DB0-885E-40FC-8C34-3F4BCAEF3A33}"/>
                </a:ext>
              </a:extLst>
            </p:cNvPr>
            <p:cNvSpPr txBox="1"/>
            <p:nvPr/>
          </p:nvSpPr>
          <p:spPr>
            <a:xfrm>
              <a:off x="3806931" y="4997424"/>
              <a:ext cx="264755" cy="2469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si2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621A1D36-142B-4412-9DC1-189DE6F6EF56}"/>
                </a:ext>
              </a:extLst>
            </p:cNvPr>
            <p:cNvSpPr txBox="1"/>
            <p:nvPr/>
          </p:nvSpPr>
          <p:spPr>
            <a:xfrm>
              <a:off x="725697" y="3333157"/>
              <a:ext cx="43208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200" dirty="0"/>
                <a:t>IB: </a:t>
              </a:r>
            </a:p>
          </p:txBody>
        </p: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78082B50-6E3D-4148-BA6E-5F0212CAB250}"/>
                </a:ext>
              </a:extLst>
            </p:cNvPr>
            <p:cNvGrpSpPr/>
            <p:nvPr/>
          </p:nvGrpSpPr>
          <p:grpSpPr>
            <a:xfrm>
              <a:off x="830766" y="3502431"/>
              <a:ext cx="502061" cy="392744"/>
              <a:chOff x="7468432" y="1049827"/>
              <a:chExt cx="502061" cy="392744"/>
            </a:xfrm>
          </p:grpSpPr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D6BA7252-F5C0-473A-9DC9-986C82A69124}"/>
                  </a:ext>
                </a:extLst>
              </p:cNvPr>
              <p:cNvSpPr txBox="1"/>
              <p:nvPr/>
            </p:nvSpPr>
            <p:spPr>
              <a:xfrm>
                <a:off x="7512810" y="1049827"/>
                <a:ext cx="4219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Ran</a:t>
                </a:r>
              </a:p>
            </p:txBody>
          </p:sp>
          <p:sp>
            <p:nvSpPr>
              <p:cNvPr id="149" name="Rectangle 148">
                <a:extLst>
                  <a:ext uri="{FF2B5EF4-FFF2-40B4-BE49-F238E27FC236}">
                    <a16:creationId xmlns:a16="http://schemas.microsoft.com/office/drawing/2014/main" id="{1BE475E0-24E5-4F09-81B3-1D401D524502}"/>
                  </a:ext>
                </a:extLst>
              </p:cNvPr>
              <p:cNvSpPr/>
              <p:nvPr/>
            </p:nvSpPr>
            <p:spPr>
              <a:xfrm>
                <a:off x="7468432" y="1180961"/>
                <a:ext cx="502061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100" dirty="0"/>
                  <a:t>(GTP)</a:t>
                </a:r>
              </a:p>
            </p:txBody>
          </p:sp>
        </p:grpSp>
        <p:grpSp>
          <p:nvGrpSpPr>
            <p:cNvPr id="150" name="Group 149">
              <a:extLst>
                <a:ext uri="{FF2B5EF4-FFF2-40B4-BE49-F238E27FC236}">
                  <a16:creationId xmlns:a16="http://schemas.microsoft.com/office/drawing/2014/main" id="{C52ACBB0-1F8E-4E55-A444-B0102571B4B9}"/>
                </a:ext>
              </a:extLst>
            </p:cNvPr>
            <p:cNvGrpSpPr/>
            <p:nvPr/>
          </p:nvGrpSpPr>
          <p:grpSpPr>
            <a:xfrm>
              <a:off x="775402" y="3879404"/>
              <a:ext cx="557425" cy="379690"/>
              <a:chOff x="7416348" y="1437402"/>
              <a:chExt cx="557425" cy="379690"/>
            </a:xfrm>
          </p:grpSpPr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816DB2EA-3B89-47BE-AC08-47FEB895DD28}"/>
                  </a:ext>
                </a:extLst>
              </p:cNvPr>
              <p:cNvSpPr txBox="1"/>
              <p:nvPr/>
            </p:nvSpPr>
            <p:spPr>
              <a:xfrm>
                <a:off x="7416348" y="1437402"/>
                <a:ext cx="5277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   Ran</a:t>
                </a:r>
              </a:p>
            </p:txBody>
          </p:sp>
          <p:sp>
            <p:nvSpPr>
              <p:cNvPr id="152" name="Rectangle 151">
                <a:extLst>
                  <a:ext uri="{FF2B5EF4-FFF2-40B4-BE49-F238E27FC236}">
                    <a16:creationId xmlns:a16="http://schemas.microsoft.com/office/drawing/2014/main" id="{9307F0EC-4D03-4204-A68F-BFA043D7AA5F}"/>
                  </a:ext>
                </a:extLst>
              </p:cNvPr>
              <p:cNvSpPr/>
              <p:nvPr/>
            </p:nvSpPr>
            <p:spPr>
              <a:xfrm>
                <a:off x="7436446" y="1555482"/>
                <a:ext cx="537327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100" dirty="0"/>
                  <a:t>(total)</a:t>
                </a:r>
              </a:p>
            </p:txBody>
          </p:sp>
        </p:grpSp>
      </p:grpSp>
      <p:grpSp>
        <p:nvGrpSpPr>
          <p:cNvPr id="231" name="Group 230">
            <a:extLst>
              <a:ext uri="{FF2B5EF4-FFF2-40B4-BE49-F238E27FC236}">
                <a16:creationId xmlns:a16="http://schemas.microsoft.com/office/drawing/2014/main" id="{FA403A95-EA12-427F-BAD7-8AAEC7972DD6}"/>
              </a:ext>
            </a:extLst>
          </p:cNvPr>
          <p:cNvGrpSpPr/>
          <p:nvPr/>
        </p:nvGrpSpPr>
        <p:grpSpPr>
          <a:xfrm>
            <a:off x="1467488" y="711929"/>
            <a:ext cx="4701360" cy="1497177"/>
            <a:chOff x="1467488" y="1634719"/>
            <a:chExt cx="4701360" cy="1497177"/>
          </a:xfrm>
        </p:grpSpPr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id="{39478E6F-4AA5-46D1-8B5E-EFB83D1476E7}"/>
                </a:ext>
              </a:extLst>
            </p:cNvPr>
            <p:cNvGrpSpPr/>
            <p:nvPr/>
          </p:nvGrpSpPr>
          <p:grpSpPr>
            <a:xfrm>
              <a:off x="5314359" y="1814474"/>
              <a:ext cx="848076" cy="1317422"/>
              <a:chOff x="2322757" y="2566175"/>
              <a:chExt cx="3464053" cy="3153140"/>
            </a:xfrm>
          </p:grpSpPr>
          <p:graphicFrame>
            <p:nvGraphicFramePr>
              <p:cNvPr id="140" name="Chart 139">
                <a:extLst>
                  <a:ext uri="{FF2B5EF4-FFF2-40B4-BE49-F238E27FC236}">
                    <a16:creationId xmlns:a16="http://schemas.microsoft.com/office/drawing/2014/main" id="{40CC807E-2E49-4A1A-8BD7-3A27383CD11F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2322757" y="2566175"/>
              <a:ext cx="3464053" cy="23520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B61E2B2F-8636-423B-ADBE-1EB6BEA938CC}"/>
                  </a:ext>
                </a:extLst>
              </p:cNvPr>
              <p:cNvSpPr txBox="1"/>
              <p:nvPr/>
            </p:nvSpPr>
            <p:spPr>
              <a:xfrm>
                <a:off x="3271043" y="4835347"/>
                <a:ext cx="423030" cy="38948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GB" sz="1200" dirty="0">
                  <a:latin typeface="+mn-lt"/>
                </a:endParaRP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7D7B457F-C860-49A0-806B-DBDEA129D77D}"/>
                  </a:ext>
                </a:extLst>
              </p:cNvPr>
              <p:cNvSpPr txBox="1"/>
              <p:nvPr/>
            </p:nvSpPr>
            <p:spPr>
              <a:xfrm>
                <a:off x="4753774" y="4835348"/>
                <a:ext cx="671831" cy="88396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GB" dirty="0">
                  <a:latin typeface="+mn-lt"/>
                </a:endParaRPr>
              </a:p>
            </p:txBody>
          </p:sp>
        </p:grp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750D8C6B-2235-42FB-B54B-55EA1FA8B8C1}"/>
                </a:ext>
              </a:extLst>
            </p:cNvPr>
            <p:cNvSpPr txBox="1"/>
            <p:nvPr/>
          </p:nvSpPr>
          <p:spPr>
            <a:xfrm rot="16200000">
              <a:off x="4627895" y="2176104"/>
              <a:ext cx="1109893" cy="174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latin typeface="+mn-lt"/>
                </a:rPr>
                <a:t>Band </a:t>
              </a:r>
              <a:r>
                <a:rPr lang="en-GB" sz="1200" dirty="0"/>
                <a:t>i</a:t>
              </a:r>
              <a:r>
                <a:rPr lang="en-GB" sz="1200" dirty="0">
                  <a:latin typeface="+mn-lt"/>
                </a:rPr>
                <a:t>ntensity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CF9CEC9A-342E-4119-B60D-960C4FE8F37A}"/>
                </a:ext>
              </a:extLst>
            </p:cNvPr>
            <p:cNvSpPr txBox="1"/>
            <p:nvPr/>
          </p:nvSpPr>
          <p:spPr>
            <a:xfrm>
              <a:off x="5605573" y="1677713"/>
              <a:ext cx="408991" cy="162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+mn-lt"/>
                </a:rPr>
                <a:t>nuclear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D2A2C989-12D4-45E3-8D05-426A626B151F}"/>
                </a:ext>
              </a:extLst>
            </p:cNvPr>
            <p:cNvSpPr txBox="1"/>
            <p:nvPr/>
          </p:nvSpPr>
          <p:spPr>
            <a:xfrm>
              <a:off x="5866442" y="2023555"/>
              <a:ext cx="285504" cy="3377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+mn-lt"/>
                </a:rPr>
                <a:t>*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B84FECA5-9EBA-49B9-B2E5-AA886F3152F4}"/>
                </a:ext>
              </a:extLst>
            </p:cNvPr>
            <p:cNvSpPr txBox="1"/>
            <p:nvPr/>
          </p:nvSpPr>
          <p:spPr>
            <a:xfrm>
              <a:off x="4945436" y="2648626"/>
              <a:ext cx="12234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Sema4D  </a:t>
              </a:r>
              <a:r>
                <a:rPr lang="en-GB" dirty="0"/>
                <a:t> -    +</a:t>
              </a:r>
            </a:p>
          </p:txBody>
        </p:sp>
        <p:grpSp>
          <p:nvGrpSpPr>
            <p:cNvPr id="230" name="Group 229">
              <a:extLst>
                <a:ext uri="{FF2B5EF4-FFF2-40B4-BE49-F238E27FC236}">
                  <a16:creationId xmlns:a16="http://schemas.microsoft.com/office/drawing/2014/main" id="{B10C0715-30A0-4C87-B25B-0A2E3D46DB0A}"/>
                </a:ext>
              </a:extLst>
            </p:cNvPr>
            <p:cNvGrpSpPr/>
            <p:nvPr/>
          </p:nvGrpSpPr>
          <p:grpSpPr>
            <a:xfrm>
              <a:off x="1467488" y="1634719"/>
              <a:ext cx="3751154" cy="1460531"/>
              <a:chOff x="638147" y="1634719"/>
              <a:chExt cx="3751154" cy="1460531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FA9564CC-0E8F-4455-8823-E92A2E2FA51D}"/>
                  </a:ext>
                </a:extLst>
              </p:cNvPr>
              <p:cNvSpPr txBox="1"/>
              <p:nvPr/>
            </p:nvSpPr>
            <p:spPr>
              <a:xfrm>
                <a:off x="1481336" y="2721544"/>
                <a:ext cx="16037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GB" sz="1200" dirty="0">
                  <a:latin typeface="+mn-lt"/>
                </a:endParaRPr>
              </a:p>
            </p:txBody>
          </p:sp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id="{0ED85F22-1618-49C1-B1B7-5F01CA5FAB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colorTemperature colorTemp="59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50698" y="1903541"/>
                <a:ext cx="831852" cy="429588"/>
              </a:xfrm>
              <a:prstGeom prst="rect">
                <a:avLst/>
              </a:prstGeom>
            </p:spPr>
          </p:pic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0B422B82-81B7-48A6-BCE7-7C9BBB8B1D87}"/>
                  </a:ext>
                </a:extLst>
              </p:cNvPr>
              <p:cNvSpPr/>
              <p:nvPr/>
            </p:nvSpPr>
            <p:spPr>
              <a:xfrm>
                <a:off x="2142941" y="1903541"/>
                <a:ext cx="839609" cy="42958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0"/>
              </a:p>
            </p:txBody>
          </p:sp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23D41BB9-BA7F-48C5-99F8-459231C4A377}"/>
                  </a:ext>
                </a:extLst>
              </p:cNvPr>
              <p:cNvGrpSpPr/>
              <p:nvPr/>
            </p:nvGrpSpPr>
            <p:grpSpPr>
              <a:xfrm>
                <a:off x="2133676" y="2395597"/>
                <a:ext cx="848874" cy="444668"/>
                <a:chOff x="4371199" y="3873327"/>
                <a:chExt cx="848874" cy="402533"/>
              </a:xfrm>
            </p:grpSpPr>
            <p:pic>
              <p:nvPicPr>
                <p:cNvPr id="131" name="Picture 130">
                  <a:extLst>
                    <a:ext uri="{FF2B5EF4-FFF2-40B4-BE49-F238E27FC236}">
                      <a16:creationId xmlns:a16="http://schemas.microsoft.com/office/drawing/2014/main" id="{5D1F0C1B-873B-48D6-AAD6-C5A176B6C3B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 cstate="print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colorTemperature colorTemp="59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71199" y="3894927"/>
                  <a:ext cx="848873" cy="380933"/>
                </a:xfrm>
                <a:prstGeom prst="rect">
                  <a:avLst/>
                </a:prstGeom>
              </p:spPr>
            </p:pic>
            <p:sp>
              <p:nvSpPr>
                <p:cNvPr id="132" name="Rectangle 131">
                  <a:extLst>
                    <a:ext uri="{FF2B5EF4-FFF2-40B4-BE49-F238E27FC236}">
                      <a16:creationId xmlns:a16="http://schemas.microsoft.com/office/drawing/2014/main" id="{1E2EE222-D33D-4494-8C0B-E9B55E2C5CD8}"/>
                    </a:ext>
                  </a:extLst>
                </p:cNvPr>
                <p:cNvSpPr/>
                <p:nvPr/>
              </p:nvSpPr>
              <p:spPr>
                <a:xfrm>
                  <a:off x="4371199" y="3873327"/>
                  <a:ext cx="848874" cy="40253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00"/>
                </a:p>
              </p:txBody>
            </p:sp>
          </p:grpSp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A507B40D-AE07-4BD2-9493-547A318D8F98}"/>
                  </a:ext>
                </a:extLst>
              </p:cNvPr>
              <p:cNvGrpSpPr/>
              <p:nvPr/>
            </p:nvGrpSpPr>
            <p:grpSpPr>
              <a:xfrm>
                <a:off x="638147" y="2725918"/>
                <a:ext cx="2579234" cy="369332"/>
                <a:chOff x="-234680" y="1981756"/>
                <a:chExt cx="2579234" cy="369332"/>
              </a:xfrm>
            </p:grpSpPr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BB5888FC-04E7-4E8D-B2CB-8CCE5828F8CE}"/>
                    </a:ext>
                  </a:extLst>
                </p:cNvPr>
                <p:cNvSpPr txBox="1"/>
                <p:nvPr/>
              </p:nvSpPr>
              <p:spPr>
                <a:xfrm>
                  <a:off x="-234680" y="2050999"/>
                  <a:ext cx="70243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+mn-lt"/>
                    </a:rPr>
                    <a:t>Sema4D</a:t>
                  </a:r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56F2A6D3-DD82-4A79-A8BC-1C2C250545AD}"/>
                    </a:ext>
                  </a:extLst>
                </p:cNvPr>
                <p:cNvSpPr txBox="1"/>
                <p:nvPr/>
              </p:nvSpPr>
              <p:spPr>
                <a:xfrm>
                  <a:off x="361368" y="1981756"/>
                  <a:ext cx="198318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dirty="0">
                      <a:latin typeface="+mn-lt"/>
                    </a:rPr>
                    <a:t> -      +        -      +</a:t>
                  </a:r>
                </a:p>
              </p:txBody>
            </p:sp>
          </p:grp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28C9C78B-5E0E-4FF7-848D-A2CF228ADC62}"/>
                  </a:ext>
                </a:extLst>
              </p:cNvPr>
              <p:cNvSpPr txBox="1"/>
              <p:nvPr/>
            </p:nvSpPr>
            <p:spPr>
              <a:xfrm>
                <a:off x="1381780" y="1634719"/>
                <a:ext cx="4516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err="1">
                    <a:latin typeface="+mn-lt"/>
                  </a:rPr>
                  <a:t>cyto</a:t>
                </a:r>
                <a:endParaRPr lang="en-GB" sz="1200" dirty="0">
                  <a:latin typeface="+mn-lt"/>
                </a:endParaRP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EA60F8CB-AA63-45E3-86B6-C0CC3DFB5804}"/>
                  </a:ext>
                </a:extLst>
              </p:cNvPr>
              <p:cNvSpPr txBox="1"/>
              <p:nvPr/>
            </p:nvSpPr>
            <p:spPr>
              <a:xfrm>
                <a:off x="2173058" y="1634719"/>
                <a:ext cx="6495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>
                    <a:latin typeface="+mn-lt"/>
                  </a:rPr>
                  <a:t>nuclear</a:t>
                </a:r>
              </a:p>
            </p:txBody>
          </p:sp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id="{ACED0F1C-010D-4AF7-B560-90EB1943A0EA}"/>
                  </a:ext>
                </a:extLst>
              </p:cNvPr>
              <p:cNvGrpSpPr/>
              <p:nvPr/>
            </p:nvGrpSpPr>
            <p:grpSpPr>
              <a:xfrm>
                <a:off x="1210364" y="2390433"/>
                <a:ext cx="861313" cy="446752"/>
                <a:chOff x="7318464" y="4494416"/>
                <a:chExt cx="861313" cy="446752"/>
              </a:xfrm>
            </p:grpSpPr>
            <p:pic>
              <p:nvPicPr>
                <p:cNvPr id="115" name="Picture 114">
                  <a:extLst>
                    <a:ext uri="{FF2B5EF4-FFF2-40B4-BE49-F238E27FC236}">
                      <a16:creationId xmlns:a16="http://schemas.microsoft.com/office/drawing/2014/main" id="{A22CD35F-D9FF-47F0-983C-9A1A1C7371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0" cstate="print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colorTemperature colorTemp="5900"/>
                          </a14:imgEffect>
                          <a14:imgEffect>
                            <a14:saturation sat="66000"/>
                          </a14:imgEffect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318464" y="4494416"/>
                  <a:ext cx="859489" cy="446752"/>
                </a:xfrm>
                <a:prstGeom prst="rect">
                  <a:avLst/>
                </a:prstGeom>
              </p:spPr>
            </p:pic>
            <p:sp>
              <p:nvSpPr>
                <p:cNvPr id="116" name="Rectangle 115">
                  <a:extLst>
                    <a:ext uri="{FF2B5EF4-FFF2-40B4-BE49-F238E27FC236}">
                      <a16:creationId xmlns:a16="http://schemas.microsoft.com/office/drawing/2014/main" id="{6F8918AF-C24E-4379-935B-4CF2105CEAC6}"/>
                    </a:ext>
                  </a:extLst>
                </p:cNvPr>
                <p:cNvSpPr/>
                <p:nvPr/>
              </p:nvSpPr>
              <p:spPr>
                <a:xfrm>
                  <a:off x="7318675" y="4494416"/>
                  <a:ext cx="861102" cy="446752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00"/>
                </a:p>
              </p:txBody>
            </p:sp>
          </p:grpSp>
          <p:grpSp>
            <p:nvGrpSpPr>
              <p:cNvPr id="105" name="Group 104">
                <a:extLst>
                  <a:ext uri="{FF2B5EF4-FFF2-40B4-BE49-F238E27FC236}">
                    <a16:creationId xmlns:a16="http://schemas.microsoft.com/office/drawing/2014/main" id="{5B1210F7-888C-4A35-9E60-0E518F62D13E}"/>
                  </a:ext>
                </a:extLst>
              </p:cNvPr>
              <p:cNvGrpSpPr/>
              <p:nvPr/>
            </p:nvGrpSpPr>
            <p:grpSpPr>
              <a:xfrm>
                <a:off x="1212763" y="1886377"/>
                <a:ext cx="861102" cy="446752"/>
                <a:chOff x="7308304" y="3990360"/>
                <a:chExt cx="861102" cy="446752"/>
              </a:xfrm>
            </p:grpSpPr>
            <p:pic>
              <p:nvPicPr>
                <p:cNvPr id="107" name="Picture 106">
                  <a:extLst>
                    <a:ext uri="{FF2B5EF4-FFF2-40B4-BE49-F238E27FC236}">
                      <a16:creationId xmlns:a16="http://schemas.microsoft.com/office/drawing/2014/main" id="{C4C38DAD-A849-4816-8415-F663F24735B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 cstate="print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colorTemperature colorTemp="59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308305" y="3990360"/>
                  <a:ext cx="859488" cy="446752"/>
                </a:xfrm>
                <a:prstGeom prst="rect">
                  <a:avLst/>
                </a:prstGeom>
              </p:spPr>
            </p:pic>
            <p:sp>
              <p:nvSpPr>
                <p:cNvPr id="108" name="Rectangle 107">
                  <a:extLst>
                    <a:ext uri="{FF2B5EF4-FFF2-40B4-BE49-F238E27FC236}">
                      <a16:creationId xmlns:a16="http://schemas.microsoft.com/office/drawing/2014/main" id="{39373BD0-1895-4196-8D91-B83668358810}"/>
                    </a:ext>
                  </a:extLst>
                </p:cNvPr>
                <p:cNvSpPr/>
                <p:nvPr/>
              </p:nvSpPr>
              <p:spPr>
                <a:xfrm>
                  <a:off x="7308304" y="3990360"/>
                  <a:ext cx="861102" cy="446752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200"/>
                </a:p>
              </p:txBody>
            </p:sp>
          </p:grp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BDFECAD5-D134-4374-A533-24A678014AE1}"/>
                  </a:ext>
                </a:extLst>
              </p:cNvPr>
              <p:cNvSpPr txBox="1"/>
              <p:nvPr/>
            </p:nvSpPr>
            <p:spPr>
              <a:xfrm>
                <a:off x="2865323" y="1634719"/>
                <a:ext cx="728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GB" sz="1200" dirty="0"/>
              </a:p>
            </p:txBody>
          </p:sp>
          <p:grpSp>
            <p:nvGrpSpPr>
              <p:cNvPr id="199" name="Group 198">
                <a:extLst>
                  <a:ext uri="{FF2B5EF4-FFF2-40B4-BE49-F238E27FC236}">
                    <a16:creationId xmlns:a16="http://schemas.microsoft.com/office/drawing/2014/main" id="{E513359F-047E-4799-B3B0-97FFDDBB803F}"/>
                  </a:ext>
                </a:extLst>
              </p:cNvPr>
              <p:cNvGrpSpPr/>
              <p:nvPr/>
            </p:nvGrpSpPr>
            <p:grpSpPr>
              <a:xfrm>
                <a:off x="740374" y="1894631"/>
                <a:ext cx="502061" cy="392744"/>
                <a:chOff x="7468432" y="1049827"/>
                <a:chExt cx="502061" cy="392744"/>
              </a:xfrm>
            </p:grpSpPr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6917ACCB-08EA-4C25-92CD-7C280D069CD4}"/>
                    </a:ext>
                  </a:extLst>
                </p:cNvPr>
                <p:cNvSpPr txBox="1"/>
                <p:nvPr/>
              </p:nvSpPr>
              <p:spPr>
                <a:xfrm>
                  <a:off x="7512810" y="1049827"/>
                  <a:ext cx="4219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Ran</a:t>
                  </a:r>
                </a:p>
              </p:txBody>
            </p:sp>
            <p:sp>
              <p:nvSpPr>
                <p:cNvPr id="223" name="Rectangle 222">
                  <a:extLst>
                    <a:ext uri="{FF2B5EF4-FFF2-40B4-BE49-F238E27FC236}">
                      <a16:creationId xmlns:a16="http://schemas.microsoft.com/office/drawing/2014/main" id="{5A463986-5FCE-4692-A162-FE0CB0274067}"/>
                    </a:ext>
                  </a:extLst>
                </p:cNvPr>
                <p:cNvSpPr/>
                <p:nvPr/>
              </p:nvSpPr>
              <p:spPr>
                <a:xfrm>
                  <a:off x="7468432" y="1180961"/>
                  <a:ext cx="502061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100" dirty="0"/>
                    <a:t>(GTP)</a:t>
                  </a:r>
                </a:p>
              </p:txBody>
            </p:sp>
          </p:grpSp>
          <p:grpSp>
            <p:nvGrpSpPr>
              <p:cNvPr id="200" name="Group 199">
                <a:extLst>
                  <a:ext uri="{FF2B5EF4-FFF2-40B4-BE49-F238E27FC236}">
                    <a16:creationId xmlns:a16="http://schemas.microsoft.com/office/drawing/2014/main" id="{D58CCA72-11C0-4C2F-A24B-96C6031206E5}"/>
                  </a:ext>
                </a:extLst>
              </p:cNvPr>
              <p:cNvGrpSpPr/>
              <p:nvPr/>
            </p:nvGrpSpPr>
            <p:grpSpPr>
              <a:xfrm>
                <a:off x="679204" y="2379556"/>
                <a:ext cx="557425" cy="379690"/>
                <a:chOff x="7416348" y="1437402"/>
                <a:chExt cx="557425" cy="379690"/>
              </a:xfrm>
            </p:grpSpPr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A7C37C61-8522-4D15-958D-617A426CA113}"/>
                    </a:ext>
                  </a:extLst>
                </p:cNvPr>
                <p:cNvSpPr txBox="1"/>
                <p:nvPr/>
              </p:nvSpPr>
              <p:spPr>
                <a:xfrm>
                  <a:off x="7416348" y="1437402"/>
                  <a:ext cx="5277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   Ran</a:t>
                  </a:r>
                </a:p>
              </p:txBody>
            </p:sp>
            <p:sp>
              <p:nvSpPr>
                <p:cNvPr id="221" name="Rectangle 220">
                  <a:extLst>
                    <a:ext uri="{FF2B5EF4-FFF2-40B4-BE49-F238E27FC236}">
                      <a16:creationId xmlns:a16="http://schemas.microsoft.com/office/drawing/2014/main" id="{84B4D1D5-579B-4468-960F-C7C44FC92388}"/>
                    </a:ext>
                  </a:extLst>
                </p:cNvPr>
                <p:cNvSpPr/>
                <p:nvPr/>
              </p:nvSpPr>
              <p:spPr>
                <a:xfrm>
                  <a:off x="7436446" y="1555482"/>
                  <a:ext cx="537327" cy="26161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100" dirty="0"/>
                    <a:t>(total)</a:t>
                  </a:r>
                </a:p>
              </p:txBody>
            </p:sp>
          </p:grp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01F8898E-4E1A-413E-9168-3A8B26D9FDC2}"/>
                  </a:ext>
                </a:extLst>
              </p:cNvPr>
              <p:cNvSpPr txBox="1"/>
              <p:nvPr/>
            </p:nvSpPr>
            <p:spPr>
              <a:xfrm>
                <a:off x="2532175" y="1792723"/>
                <a:ext cx="185712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/>
                  <a:t>            IP:</a:t>
                </a:r>
              </a:p>
              <a:p>
                <a:r>
                  <a:rPr lang="en-GB" sz="1200" dirty="0"/>
                  <a:t>            RanBP1(RBD)-GST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CE7B2496-76DD-409E-A7BF-ED9AC395F185}"/>
                  </a:ext>
                </a:extLst>
              </p:cNvPr>
              <p:cNvSpPr txBox="1"/>
              <p:nvPr/>
            </p:nvSpPr>
            <p:spPr>
              <a:xfrm rot="5400000">
                <a:off x="2868901" y="2507773"/>
                <a:ext cx="511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input</a:t>
                </a:r>
              </a:p>
            </p:txBody>
          </p: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D0898796-32CD-437A-A5FB-F0612FCCFA83}"/>
                  </a:ext>
                </a:extLst>
              </p:cNvPr>
              <p:cNvSpPr txBox="1"/>
              <p:nvPr/>
            </p:nvSpPr>
            <p:spPr>
              <a:xfrm>
                <a:off x="695403" y="1719483"/>
                <a:ext cx="432081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dirty="0"/>
                  <a:t>IB: </a:t>
                </a:r>
              </a:p>
            </p:txBody>
          </p:sp>
        </p:grpSp>
      </p:grpSp>
      <p:sp>
        <p:nvSpPr>
          <p:cNvPr id="134" name="TextBox 133">
            <a:extLst>
              <a:ext uri="{FF2B5EF4-FFF2-40B4-BE49-F238E27FC236}">
                <a16:creationId xmlns:a16="http://schemas.microsoft.com/office/drawing/2014/main" id="{44D82257-CD3D-4D57-AC4D-9F29470E9918}"/>
              </a:ext>
            </a:extLst>
          </p:cNvPr>
          <p:cNvSpPr txBox="1"/>
          <p:nvPr/>
        </p:nvSpPr>
        <p:spPr>
          <a:xfrm>
            <a:off x="9768444" y="1877669"/>
            <a:ext cx="285504" cy="3377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latin typeface="+mn-lt"/>
              </a:rPr>
              <a:t>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874243D-B937-EBF2-433E-D6D24F4EC73E}"/>
              </a:ext>
            </a:extLst>
          </p:cNvPr>
          <p:cNvSpPr txBox="1"/>
          <p:nvPr/>
        </p:nvSpPr>
        <p:spPr>
          <a:xfrm>
            <a:off x="1388907" y="4474222"/>
            <a:ext cx="9760061" cy="23817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 7. PlexinB1 and PlexinB2 regulate levels of GTP-bound Ran in LNCaP cells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ssociated with figure 4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).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NCaP cells were treated with Sema4D or vehicle control for 15mins and were then fractionated into cytoplasmic and nuclear fractions and immunoprecipitated with RanBP1(RBD)-GST and the ratio of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o total Ran assessed by immunoblotting. Bar chart of average band intensities, nuclear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/nuclear total Ran, (n=4, *p=&lt;0.01,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udent T-Test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).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NCaP cells were treated with non-silencing siRNA or siRNA to PlexinB1 and the ratio of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o total Ran assessed by pulldown with RanBP1(RBD)-GST followed by immunoblotting. Bar chart of average band intensities,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/total Ran, (n=4, *p=&lt;0.05,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udent T-Test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).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ecrease in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evels upon Sema4D treatment of LNCaP cells is reversed by overexpression of RCC1.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LNCaP cells were transfected with empty vector or RCC1-HA and were then treated with Sema4D or vehicle control for 15mins.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evels were detected by pulldown with RanBP1(RBD)-GST and the ratio of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o total Ran was assessed by immunoblotting.</a:t>
            </a:r>
            <a:r>
              <a:rPr lang="en-GB" sz="1200" strike="sngStrike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ma4D treatment resulted in a decrease in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anGTP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levels in cells transfected with vector but not RCC1. Bar chart of band intensity (n=3, *p=&lt;0.05,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udent T-Test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0252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0</Words>
  <Application>Microsoft Office PowerPoint</Application>
  <PresentationFormat>Widescreen</PresentationFormat>
  <Paragraphs>6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43:54Z</dcterms:created>
  <dcterms:modified xsi:type="dcterms:W3CDTF">2023-06-02T16:44:37Z</dcterms:modified>
</cp:coreProperties>
</file>